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 showGuides="1">
      <p:cViewPr varScale="1">
        <p:scale>
          <a:sx n="83" d="100"/>
          <a:sy n="83" d="100"/>
        </p:scale>
        <p:origin x="686" y="77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6B4EE6-68D6-BBBF-C214-18B3544FBC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7A930D8-FC98-7511-C8A9-A30C9AD668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3874A7C-62B5-A86D-63AE-D01542148F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69EB5AA-FEEF-318A-4F2E-18FFF2B81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FE9B4C1-C49D-D989-E422-C06A0E91CF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7375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AF0A15-07E2-C256-E8C6-F4F37AA941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4F4D02A-1AA2-4F33-03F5-456C94E8CC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43CA38D-85BD-F118-C552-93AD0E66D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343575-5749-9E05-8671-1747DE0DB1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AB5A6E1-0CED-8FEA-07F7-8BB46C3F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95655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90FE30D-B8D3-9B05-DEBC-8DBE22C993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40BE338-E9DA-B340-3FA5-2F70B15092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FC00D3-ABCD-2355-86AF-FFCE891FF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3722053-EEFA-3F55-57F9-4A03426961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AA440E-F6F7-00BC-F9C9-D176411A1F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8430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0AF6106-7AF4-166D-810F-C24EF70A60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A857E7B-1F60-C5D7-9A6E-B7F945FBFA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7999C5E-6E83-154B-CD8E-0C918F4B26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7477C3-8B61-AE6B-F5B9-45AC440E8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5EBF66-56F9-29F9-7B51-B9AD70BDB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2324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4BBE06A-D356-BCE6-0E55-50EAB086A1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53E457E-BA3D-F12D-3B20-71FE9F4001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520041-A466-3E92-73AB-883BC65609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0F8EBA-9593-1D2E-2B1F-2B53F50E3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5E3AC5-3C50-32BB-C65B-06FBC235D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75131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61422F3-BB7E-9D92-018D-EE782E6DF1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D4071CF-A1A8-CE10-5E74-DAFAF1AD0D1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053AB11-5F92-C4C2-9421-01597B1E5D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85543E7-60B9-BDF3-CDD8-FCCE8414B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FD55EA0-F0E9-76A7-202E-095B3E9DE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981BD8C-F8FF-0271-DEB9-CD529483A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614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AE161E-0D84-DD4D-E018-491D16797D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5BFFEE7-A544-D96C-AEF8-BD3511D37B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D68DB44-BBEC-E8DA-1C9A-24DC4B39D0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06A4ECC1-01CE-318F-B016-30C7884EF9E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B761144-79E5-6FD1-B510-76BFC10A47A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071BA8C-623A-3A02-56EE-6FC00FAF6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EC94CB7-E823-14B5-20A5-3CC3B2FB8B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C7BBA0A-A1B0-9F14-8F39-C6CFF81C9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75893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45D14B-8466-0403-BC82-8ECE85BF30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44AA728-2BFC-5D4C-25BE-18BC811D2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D7E3788-1AE4-E647-86C1-3033D49AE2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3CB6EE5-9C12-D413-1484-B3DEE6C12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3299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9C1E967-88E2-2114-5A33-5F9B7A035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830B2DF-EA9B-8E05-7B53-58AC89FB49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03EC6E2-98E6-34D8-1852-CAE59FCDF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4951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7F87A3-0B32-78DC-7382-3814175E5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A772DAA-D6DF-2A70-E025-416403A3EA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3A8CD5A-AC9E-5E72-6B41-32C3705F00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E3229BB-0EE1-E4D6-9138-75D0709EAC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B4386A7-0E32-BC4A-9F75-F218D23D0B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D44B30D-8951-8940-5054-624CC20B4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2509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260A8D-03BF-4553-EA00-33BAF257E8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DE4AD87-8B44-0A66-F151-BC95BBC38A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3852FE5-A5B4-2781-A9EF-2D110FFE96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B41F909-4940-B5E1-BD8A-8DFE7F20C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B7E524D-66DF-EDEE-E5D0-4672873F1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FFF1FE-E0A4-F8D2-A42C-D289B655BA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996093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80CE531-9BE0-C2FA-87B9-A5AEC95D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EC53151-C222-1AFE-4C19-467430C6C1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FC6BBD-62F1-0A44-628F-1ED2EB1B88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00A12C-7698-4091-B4EC-5808D81D6EAE}" type="datetimeFigureOut">
              <a:rPr lang="zh-CN" altLang="en-US" smtClean="0"/>
              <a:t>2023/6/1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382AA99-0726-80EA-600B-0FE916AD1E8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6B33C2-BA26-E847-7A54-8DCFD5D1CD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E0AB82-0C9D-45B3-88B2-EC1469E2DC9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88612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1C9591C-F869-EFD4-BB58-81FCBA00B2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0681" y="452926"/>
            <a:ext cx="5218784" cy="480071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DEE33FDD-B8DD-7C78-08F7-149B8E68C5C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06340" y="452926"/>
            <a:ext cx="6685660" cy="4800717"/>
          </a:xfrm>
          <a:prstGeom prst="rect">
            <a:avLst/>
          </a:prstGeom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D3210499-0A0D-2AB4-B6CB-6CB0CCD036B3}"/>
              </a:ext>
            </a:extLst>
          </p:cNvPr>
          <p:cNvSpPr txBox="1"/>
          <p:nvPr/>
        </p:nvSpPr>
        <p:spPr>
          <a:xfrm>
            <a:off x="166977" y="59442"/>
            <a:ext cx="2472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3A0C4E7-8F85-9FBA-12BB-59D0D557CEF7}"/>
              </a:ext>
            </a:extLst>
          </p:cNvPr>
          <p:cNvSpPr txBox="1"/>
          <p:nvPr/>
        </p:nvSpPr>
        <p:spPr>
          <a:xfrm>
            <a:off x="820681" y="5541294"/>
            <a:ext cx="8754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A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nal structure of  AKT1-17 beta estradiol complex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34172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D3210499-0A0D-2AB4-B6CB-6CB0CCD036B3}"/>
              </a:ext>
            </a:extLst>
          </p:cNvPr>
          <p:cNvSpPr txBox="1"/>
          <p:nvPr/>
        </p:nvSpPr>
        <p:spPr>
          <a:xfrm>
            <a:off x="166977" y="59442"/>
            <a:ext cx="2472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3A0C4E7-8F85-9FBA-12BB-59D0D557CEF7}"/>
              </a:ext>
            </a:extLst>
          </p:cNvPr>
          <p:cNvSpPr txBox="1"/>
          <p:nvPr/>
        </p:nvSpPr>
        <p:spPr>
          <a:xfrm>
            <a:off x="820681" y="5541294"/>
            <a:ext cx="8754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B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nal structure of  AKT1-estrone complex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98760E20-BE88-17E3-9A04-92DFDC79683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361" y="1016758"/>
            <a:ext cx="6559661" cy="4271749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EA39B5A-BC3B-6C37-2F32-310E3F8058A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05474" y="1016759"/>
            <a:ext cx="5782762" cy="42717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50934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D3210499-0A0D-2AB4-B6CB-6CB0CCD036B3}"/>
              </a:ext>
            </a:extLst>
          </p:cNvPr>
          <p:cNvSpPr txBox="1"/>
          <p:nvPr/>
        </p:nvSpPr>
        <p:spPr>
          <a:xfrm>
            <a:off x="166977" y="59442"/>
            <a:ext cx="2472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3A0C4E7-8F85-9FBA-12BB-59D0D557CEF7}"/>
              </a:ext>
            </a:extLst>
          </p:cNvPr>
          <p:cNvSpPr txBox="1"/>
          <p:nvPr/>
        </p:nvSpPr>
        <p:spPr>
          <a:xfrm>
            <a:off x="820681" y="5541294"/>
            <a:ext cx="8754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C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nal structure of  MAPK3-17 beta estradiol complex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812D93DC-1AB8-57F9-553C-11D166312F2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102" y="947374"/>
            <a:ext cx="8516277" cy="431176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B460321-1FCC-5394-7B66-C606AD4604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4705" y="947373"/>
            <a:ext cx="6397295" cy="43117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34838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D3210499-0A0D-2AB4-B6CB-6CB0CCD036B3}"/>
              </a:ext>
            </a:extLst>
          </p:cNvPr>
          <p:cNvSpPr txBox="1"/>
          <p:nvPr/>
        </p:nvSpPr>
        <p:spPr>
          <a:xfrm>
            <a:off x="166977" y="59442"/>
            <a:ext cx="2472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3A0C4E7-8F85-9FBA-12BB-59D0D557CEF7}"/>
              </a:ext>
            </a:extLst>
          </p:cNvPr>
          <p:cNvSpPr txBox="1"/>
          <p:nvPr/>
        </p:nvSpPr>
        <p:spPr>
          <a:xfrm>
            <a:off x="820681" y="5541294"/>
            <a:ext cx="87543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D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nal structure of  MAPK3-estrone complex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FCEE456-8D26-3E0F-743F-47EB4584C8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722" y="947374"/>
            <a:ext cx="6213366" cy="3916908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ADC601C-E854-8230-1992-C5A730498F7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9401" y="947374"/>
            <a:ext cx="5661877" cy="39169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43457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1</TotalTime>
  <Words>44</Words>
  <Application>Microsoft Office PowerPoint</Application>
  <PresentationFormat>Widescreen</PresentationFormat>
  <Paragraphs>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 凌宇</dc:creator>
  <cp:lastModifiedBy>MDPI</cp:lastModifiedBy>
  <cp:revision>2</cp:revision>
  <dcterms:created xsi:type="dcterms:W3CDTF">2023-05-20T08:24:21Z</dcterms:created>
  <dcterms:modified xsi:type="dcterms:W3CDTF">2023-06-15T01:25:06Z</dcterms:modified>
</cp:coreProperties>
</file>